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919476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2600" y="3993120"/>
            <a:ext cx="919476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2600" y="39931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83920" y="39931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481560" y="14857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90880" y="14857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2600" y="39931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481560" y="39931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90880" y="39931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2600" y="1485720"/>
            <a:ext cx="9194760" cy="4800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919476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12920" y="264960"/>
            <a:ext cx="8129520" cy="434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2600" y="39931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83920" y="39931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2600" y="3993120"/>
            <a:ext cx="919476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body"/>
          </p:nvPr>
        </p:nvSpPr>
        <p:spPr>
          <a:xfrm>
            <a:off x="372600" y="1485720"/>
            <a:ext cx="919476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1500"/>
              </a:spcBef>
              <a:buClr>
                <a:srgbClr val="3333cc"/>
              </a:buClr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1500"/>
              </a:spcBef>
              <a:buClr>
                <a:srgbClr val="3333cc"/>
              </a:buClr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1500"/>
              </a:spcBef>
              <a:buClr>
                <a:srgbClr val="3333cc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1500"/>
              </a:spcBef>
              <a:buClr>
                <a:srgbClr val="3333cc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1500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1500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1500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"/>
          <p:cNvSpPr/>
          <p:nvPr/>
        </p:nvSpPr>
        <p:spPr>
          <a:xfrm>
            <a:off x="423720" y="260280"/>
            <a:ext cx="8131320" cy="936720"/>
          </a:xfrm>
          <a:custGeom>
            <a:avLst/>
            <a:gdLst/>
            <a:ahLst/>
            <a:rect l="l" t="t" r="r" b="b"/>
            <a:pathLst>
              <a:path w="4248" h="772">
                <a:moveTo>
                  <a:pt x="0" y="0"/>
                </a:moveTo>
                <a:lnTo>
                  <a:pt x="4247" y="0"/>
                </a:lnTo>
                <a:lnTo>
                  <a:pt x="4247" y="771"/>
                </a:lnTo>
                <a:lnTo>
                  <a:pt x="0" y="771"/>
                </a:lnTo>
                <a:lnTo>
                  <a:pt x="0" y="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"/>
          <p:cNvSpPr/>
          <p:nvPr/>
        </p:nvSpPr>
        <p:spPr>
          <a:xfrm>
            <a:off x="423720" y="6357960"/>
            <a:ext cx="9050400" cy="160200"/>
          </a:xfrm>
          <a:custGeom>
            <a:avLst/>
            <a:gdLst/>
            <a:ahLst/>
            <a:rect l="l" t="t" r="r" b="b"/>
            <a:pathLst>
              <a:path w="5256" h="101">
                <a:moveTo>
                  <a:pt x="0" y="0"/>
                </a:moveTo>
                <a:lnTo>
                  <a:pt x="5255" y="0"/>
                </a:lnTo>
                <a:lnTo>
                  <a:pt x="5255" y="100"/>
                </a:lnTo>
                <a:lnTo>
                  <a:pt x="0" y="100"/>
                </a:lnTo>
                <a:lnTo>
                  <a:pt x="0" y="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"/>
          <p:cNvSpPr/>
          <p:nvPr/>
        </p:nvSpPr>
        <p:spPr>
          <a:xfrm>
            <a:off x="425520" y="1557360"/>
            <a:ext cx="9064440" cy="460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400040" y="2295360"/>
            <a:ext cx="3067200" cy="181008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5388120" y="2300400"/>
            <a:ext cx="3066840" cy="180000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1795320" y="3824280"/>
            <a:ext cx="725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AP-Myc_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5770440" y="3836880"/>
            <a:ext cx="725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AP-Myc_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5" name=""/>
          <p:cNvGrpSpPr/>
          <p:nvPr/>
        </p:nvGrpSpPr>
        <p:grpSpPr>
          <a:xfrm>
            <a:off x="1630440" y="4168800"/>
            <a:ext cx="2882880" cy="374760"/>
            <a:chOff x="1630440" y="4168800"/>
            <a:chExt cx="2882880" cy="374760"/>
          </a:xfrm>
        </p:grpSpPr>
        <p:sp>
          <p:nvSpPr>
            <p:cNvPr id="46" name=""/>
            <p:cNvSpPr/>
            <p:nvPr/>
          </p:nvSpPr>
          <p:spPr>
            <a:xfrm>
              <a:off x="1630440" y="4290840"/>
              <a:ext cx="157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otal gene datase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997360" y="4297320"/>
              <a:ext cx="151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ycling gene datase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48" name=""/>
            <p:cNvGrpSpPr/>
            <p:nvPr/>
          </p:nvGrpSpPr>
          <p:grpSpPr>
            <a:xfrm>
              <a:off x="3144960" y="4168800"/>
              <a:ext cx="1230120" cy="54000"/>
              <a:chOff x="3144960" y="4168800"/>
              <a:chExt cx="1230120" cy="54000"/>
            </a:xfrm>
          </p:grpSpPr>
          <p:sp>
            <p:nvSpPr>
              <p:cNvPr id="49" name=""/>
              <p:cNvSpPr/>
              <p:nvPr/>
            </p:nvSpPr>
            <p:spPr>
              <a:xfrm>
                <a:off x="395064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401688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408420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368244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0000"/>
              </a:solidFill>
              <a:ln w="3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374832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ff"/>
              </a:solidFill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381600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ff"/>
              </a:solidFill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388332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341280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noFill/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348048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00"/>
              </a:solidFill>
              <a:ln w="3240">
                <a:solidFill>
                  <a:srgbClr val="ff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354780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00"/>
              </a:solidFill>
              <a:ln w="3240">
                <a:solidFill>
                  <a:srgbClr val="ff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361368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0000"/>
              </a:solidFill>
              <a:ln w="3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314496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321228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327924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334548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415152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421884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428508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ff"/>
              </a:solidFill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67" name=""/>
            <p:cNvGrpSpPr/>
            <p:nvPr/>
          </p:nvGrpSpPr>
          <p:grpSpPr>
            <a:xfrm>
              <a:off x="1812960" y="4168800"/>
              <a:ext cx="1231920" cy="54000"/>
              <a:chOff x="1812960" y="4168800"/>
              <a:chExt cx="1231920" cy="54000"/>
            </a:xfrm>
          </p:grpSpPr>
          <p:sp>
            <p:nvSpPr>
              <p:cNvPr id="68" name=""/>
              <p:cNvSpPr/>
              <p:nvPr/>
            </p:nvSpPr>
            <p:spPr>
              <a:xfrm>
                <a:off x="261972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268596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275328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235116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0000"/>
              </a:solidFill>
              <a:ln w="3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417040" y="4168800"/>
                <a:ext cx="90360" cy="54000"/>
              </a:xfrm>
              <a:custGeom>
                <a:avLst/>
                <a:gdLst>
                  <a:gd name="textAreaLeft" fmla="*/ 0 w 90360"/>
                  <a:gd name="textAreaRight" fmla="*/ 90720 w 903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ff"/>
              </a:solidFill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2484720" y="4168800"/>
                <a:ext cx="90360" cy="54000"/>
              </a:xfrm>
              <a:custGeom>
                <a:avLst/>
                <a:gdLst>
                  <a:gd name="textAreaLeft" fmla="*/ 0 w 90360"/>
                  <a:gd name="textAreaRight" fmla="*/ 90720 w 903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ff"/>
              </a:solidFill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55204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081160" y="4168800"/>
                <a:ext cx="90360" cy="54000"/>
              </a:xfrm>
              <a:custGeom>
                <a:avLst/>
                <a:gdLst>
                  <a:gd name="textAreaLeft" fmla="*/ 0 w 90360"/>
                  <a:gd name="textAreaRight" fmla="*/ 90720 w 903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noFill/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214884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00"/>
              </a:solidFill>
              <a:ln w="3240">
                <a:solidFill>
                  <a:srgbClr val="ff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21616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00"/>
              </a:solidFill>
              <a:ln w="3240">
                <a:solidFill>
                  <a:srgbClr val="ff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2282400" y="4168800"/>
                <a:ext cx="90360" cy="54000"/>
              </a:xfrm>
              <a:custGeom>
                <a:avLst/>
                <a:gdLst>
                  <a:gd name="textAreaLeft" fmla="*/ 0 w 90360"/>
                  <a:gd name="textAreaRight" fmla="*/ 90720 w 903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0000"/>
              </a:solidFill>
              <a:ln w="3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181296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188028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1947600" y="4168800"/>
                <a:ext cx="89280" cy="54000"/>
              </a:xfrm>
              <a:custGeom>
                <a:avLst/>
                <a:gdLst>
                  <a:gd name="textAreaLeft" fmla="*/ 0 w 89280"/>
                  <a:gd name="textAreaRight" fmla="*/ 89640 w 8928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2013840" y="4168800"/>
                <a:ext cx="90360" cy="54000"/>
              </a:xfrm>
              <a:custGeom>
                <a:avLst/>
                <a:gdLst>
                  <a:gd name="textAreaLeft" fmla="*/ 0 w 90360"/>
                  <a:gd name="textAreaRight" fmla="*/ 90720 w 903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282096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2887920" y="4168800"/>
                <a:ext cx="89280" cy="54000"/>
              </a:xfrm>
              <a:custGeom>
                <a:avLst/>
                <a:gdLst>
                  <a:gd name="textAreaLeft" fmla="*/ 0 w 89280"/>
                  <a:gd name="textAreaRight" fmla="*/ 89640 w 8928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2954520" y="4168800"/>
                <a:ext cx="90360" cy="54000"/>
              </a:xfrm>
              <a:custGeom>
                <a:avLst/>
                <a:gdLst>
                  <a:gd name="textAreaLeft" fmla="*/ 0 w 90360"/>
                  <a:gd name="textAreaRight" fmla="*/ 90720 w 903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ff"/>
              </a:solidFill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86" name=""/>
          <p:cNvGrpSpPr/>
          <p:nvPr/>
        </p:nvGrpSpPr>
        <p:grpSpPr>
          <a:xfrm>
            <a:off x="5592600" y="4168800"/>
            <a:ext cx="2882880" cy="374760"/>
            <a:chOff x="5592600" y="4168800"/>
            <a:chExt cx="2882880" cy="374760"/>
          </a:xfrm>
        </p:grpSpPr>
        <p:sp>
          <p:nvSpPr>
            <p:cNvPr id="87" name=""/>
            <p:cNvSpPr/>
            <p:nvPr/>
          </p:nvSpPr>
          <p:spPr>
            <a:xfrm>
              <a:off x="5592600" y="4290840"/>
              <a:ext cx="157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otal gene datase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6959520" y="4297320"/>
              <a:ext cx="151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ycling gene datase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89" name=""/>
            <p:cNvGrpSpPr/>
            <p:nvPr/>
          </p:nvGrpSpPr>
          <p:grpSpPr>
            <a:xfrm>
              <a:off x="7107120" y="4168800"/>
              <a:ext cx="1230120" cy="54000"/>
              <a:chOff x="7107120" y="4168800"/>
              <a:chExt cx="1230120" cy="54000"/>
            </a:xfrm>
          </p:grpSpPr>
          <p:sp>
            <p:nvSpPr>
              <p:cNvPr id="90" name=""/>
              <p:cNvSpPr/>
              <p:nvPr/>
            </p:nvSpPr>
            <p:spPr>
              <a:xfrm>
                <a:off x="791280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797904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804636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764460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0000"/>
              </a:solidFill>
              <a:ln w="3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771048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ff"/>
              </a:solidFill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777816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ff"/>
              </a:solidFill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784548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737496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noFill/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744264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00"/>
              </a:solidFill>
              <a:ln w="3240">
                <a:solidFill>
                  <a:srgbClr val="ff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750996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00"/>
              </a:solidFill>
              <a:ln w="3240">
                <a:solidFill>
                  <a:srgbClr val="ff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757584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0000"/>
              </a:solidFill>
              <a:ln w="3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710712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717444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724140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730764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811368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818100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824724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ff"/>
              </a:solidFill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08" name=""/>
            <p:cNvGrpSpPr/>
            <p:nvPr/>
          </p:nvGrpSpPr>
          <p:grpSpPr>
            <a:xfrm>
              <a:off x="5775120" y="4168800"/>
              <a:ext cx="1231920" cy="54000"/>
              <a:chOff x="5775120" y="4168800"/>
              <a:chExt cx="1231920" cy="54000"/>
            </a:xfrm>
          </p:grpSpPr>
          <p:sp>
            <p:nvSpPr>
              <p:cNvPr id="109" name=""/>
              <p:cNvSpPr/>
              <p:nvPr/>
            </p:nvSpPr>
            <p:spPr>
              <a:xfrm>
                <a:off x="658188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664812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671544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631332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0000"/>
              </a:solidFill>
              <a:ln w="3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6379200" y="4168800"/>
                <a:ext cx="90360" cy="54000"/>
              </a:xfrm>
              <a:custGeom>
                <a:avLst/>
                <a:gdLst>
                  <a:gd name="textAreaLeft" fmla="*/ 0 w 90360"/>
                  <a:gd name="textAreaRight" fmla="*/ 90720 w 903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ff"/>
              </a:solidFill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6446880" y="4168800"/>
                <a:ext cx="90360" cy="54000"/>
              </a:xfrm>
              <a:custGeom>
                <a:avLst/>
                <a:gdLst>
                  <a:gd name="textAreaLeft" fmla="*/ 0 w 90360"/>
                  <a:gd name="textAreaRight" fmla="*/ 90720 w 903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ff"/>
              </a:solidFill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651420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6043320" y="4168800"/>
                <a:ext cx="90360" cy="54000"/>
              </a:xfrm>
              <a:custGeom>
                <a:avLst/>
                <a:gdLst>
                  <a:gd name="textAreaLeft" fmla="*/ 0 w 90360"/>
                  <a:gd name="textAreaRight" fmla="*/ 90720 w 903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noFill/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611100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00"/>
              </a:solidFill>
              <a:ln w="3240">
                <a:solidFill>
                  <a:srgbClr val="ff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617832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00"/>
              </a:solidFill>
              <a:ln w="3240">
                <a:solidFill>
                  <a:srgbClr val="ff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6244560" y="4168800"/>
                <a:ext cx="90360" cy="54000"/>
              </a:xfrm>
              <a:custGeom>
                <a:avLst/>
                <a:gdLst>
                  <a:gd name="textAreaLeft" fmla="*/ 0 w 90360"/>
                  <a:gd name="textAreaRight" fmla="*/ 90720 w 903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0000"/>
              </a:solidFill>
              <a:ln w="3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577512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5842440" y="4168800"/>
                <a:ext cx="88920" cy="540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5909760" y="4168800"/>
                <a:ext cx="89280" cy="54000"/>
              </a:xfrm>
              <a:custGeom>
                <a:avLst/>
                <a:gdLst>
                  <a:gd name="textAreaLeft" fmla="*/ 0 w 89280"/>
                  <a:gd name="textAreaRight" fmla="*/ 89640 w 8928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5976000" y="4168800"/>
                <a:ext cx="90360" cy="54000"/>
              </a:xfrm>
              <a:custGeom>
                <a:avLst/>
                <a:gdLst>
                  <a:gd name="textAreaLeft" fmla="*/ 0 w 90360"/>
                  <a:gd name="textAreaRight" fmla="*/ 90720 w 903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cc99ff"/>
              </a:solidFill>
              <a:ln w="324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6783120" y="4168800"/>
                <a:ext cx="90000" cy="54000"/>
              </a:xfrm>
              <a:custGeom>
                <a:avLst/>
                <a:gdLst>
                  <a:gd name="textAreaLeft" fmla="*/ 0 w 90000"/>
                  <a:gd name="textAreaRight" fmla="*/ 90360 w 900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6850080" y="4168800"/>
                <a:ext cx="89280" cy="54000"/>
              </a:xfrm>
              <a:custGeom>
                <a:avLst/>
                <a:gdLst>
                  <a:gd name="textAreaLeft" fmla="*/ 0 w 89280"/>
                  <a:gd name="textAreaRight" fmla="*/ 89640 w 8928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00ffff"/>
              </a:solidFill>
              <a:ln w="324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6916680" y="4168800"/>
                <a:ext cx="90360" cy="54000"/>
              </a:xfrm>
              <a:custGeom>
                <a:avLst/>
                <a:gdLst>
                  <a:gd name="textAreaLeft" fmla="*/ 0 w 90360"/>
                  <a:gd name="textAreaRight" fmla="*/ 90720 w 903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6200" y="0"/>
                    </a:lnTo>
                    <a:lnTo>
                      <a:pt x="21600" y="10800"/>
                    </a:lnTo>
                    <a:lnTo>
                      <a:pt x="16200" y="21600"/>
                    </a:lnTo>
                    <a:lnTo>
                      <a:pt x="0" y="21600"/>
                    </a:lnTo>
                    <a:lnTo>
                      <a:pt x="5400" y="10800"/>
                    </a:lnTo>
                    <a:close/>
                  </a:path>
                </a:pathLst>
              </a:custGeom>
              <a:solidFill>
                <a:srgbClr val="ffffff"/>
              </a:solidFill>
              <a:ln w="3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560" bIns="75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sp>
        <p:nvSpPr>
          <p:cNvPr id="127" name=""/>
          <p:cNvSpPr/>
          <p:nvPr/>
        </p:nvSpPr>
        <p:spPr>
          <a:xfrm rot="16200000">
            <a:off x="527760" y="3079800"/>
            <a:ext cx="130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CS scor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6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1999-12-04T05:57:58Z</dcterms:created>
  <dc:creator>NRRC Client</dc:creator>
  <dc:description/>
  <dc:language>en-US</dc:language>
  <cp:lastModifiedBy>中外製薬株式会社</cp:lastModifiedBy>
  <cp:lastPrinted>2000-04-18T05:06:02Z</cp:lastPrinted>
  <dcterms:modified xsi:type="dcterms:W3CDTF">2009-02-27T11:38:59Z</dcterms:modified>
  <cp:revision>1049</cp:revision>
  <dc:subject/>
  <dc:title>ｽﾗｲﾄﾞ ﾀｲﾄﾙなし</dc:title>
</cp:coreProperties>
</file>